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8288000" cy="10972800"/>
  <p:notesSz cx="6858000" cy="9144000"/>
  <p:defaultTextStyle>
    <a:defPPr>
      <a:defRPr lang="en-US"/>
    </a:defPPr>
    <a:lvl1pPr marL="0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50221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00443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50664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00885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51107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901326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51548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201769" algn="l" defTabSz="1300443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574" autoAdjust="0"/>
    <p:restoredTop sz="94643" autoAdjust="0"/>
  </p:normalViewPr>
  <p:slideViewPr>
    <p:cSldViewPr>
      <p:cViewPr varScale="1">
        <p:scale>
          <a:sx n="77" d="100"/>
          <a:sy n="77" d="100"/>
        </p:scale>
        <p:origin x="-1602" y="-108"/>
      </p:cViewPr>
      <p:guideLst>
        <p:guide orient="horz" pos="3456"/>
        <p:guide pos="57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3408685"/>
            <a:ext cx="15544800" cy="23520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0" y="6217920"/>
            <a:ext cx="1280160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02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04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06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0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11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13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15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17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0" y="439425"/>
            <a:ext cx="4114800" cy="936244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439425"/>
            <a:ext cx="12039600" cy="936244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27" y="7051044"/>
            <a:ext cx="15544800" cy="2179320"/>
          </a:xfrm>
        </p:spPr>
        <p:txBody>
          <a:bodyPr anchor="t"/>
          <a:lstStyle>
            <a:lvl1pPr algn="l">
              <a:defRPr sz="5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27" y="4650743"/>
            <a:ext cx="15544800" cy="240029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50221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00443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195066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60088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5110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90132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55154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20176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2560325"/>
            <a:ext cx="8077200" cy="7241541"/>
          </a:xfrm>
        </p:spPr>
        <p:txBody>
          <a:bodyPr/>
          <a:lstStyle>
            <a:lvl1pPr>
              <a:defRPr sz="4000"/>
            </a:lvl1pPr>
            <a:lvl2pPr>
              <a:defRPr sz="34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2560325"/>
            <a:ext cx="8077200" cy="7241541"/>
          </a:xfrm>
        </p:spPr>
        <p:txBody>
          <a:bodyPr/>
          <a:lstStyle>
            <a:lvl1pPr>
              <a:defRPr sz="4000"/>
            </a:lvl1pPr>
            <a:lvl2pPr>
              <a:defRPr sz="34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2456181"/>
            <a:ext cx="8080376" cy="1023619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50221" indent="0">
              <a:buNone/>
              <a:defRPr sz="2800" b="1"/>
            </a:lvl2pPr>
            <a:lvl3pPr marL="1300443" indent="0">
              <a:buNone/>
              <a:defRPr sz="2600" b="1"/>
            </a:lvl3pPr>
            <a:lvl4pPr marL="1950664" indent="0">
              <a:buNone/>
              <a:defRPr sz="2300" b="1"/>
            </a:lvl4pPr>
            <a:lvl5pPr marL="2600885" indent="0">
              <a:buNone/>
              <a:defRPr sz="2300" b="1"/>
            </a:lvl5pPr>
            <a:lvl6pPr marL="3251107" indent="0">
              <a:buNone/>
              <a:defRPr sz="2300" b="1"/>
            </a:lvl6pPr>
            <a:lvl7pPr marL="3901326" indent="0">
              <a:buNone/>
              <a:defRPr sz="2300" b="1"/>
            </a:lvl7pPr>
            <a:lvl8pPr marL="4551548" indent="0">
              <a:buNone/>
              <a:defRPr sz="2300" b="1"/>
            </a:lvl8pPr>
            <a:lvl9pPr marL="5201769" indent="0">
              <a:buNone/>
              <a:defRPr sz="2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0" y="3479800"/>
            <a:ext cx="8080376" cy="6322061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6" y="2456181"/>
            <a:ext cx="8083551" cy="1023619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50221" indent="0">
              <a:buNone/>
              <a:defRPr sz="2800" b="1"/>
            </a:lvl2pPr>
            <a:lvl3pPr marL="1300443" indent="0">
              <a:buNone/>
              <a:defRPr sz="2600" b="1"/>
            </a:lvl3pPr>
            <a:lvl4pPr marL="1950664" indent="0">
              <a:buNone/>
              <a:defRPr sz="2300" b="1"/>
            </a:lvl4pPr>
            <a:lvl5pPr marL="2600885" indent="0">
              <a:buNone/>
              <a:defRPr sz="2300" b="1"/>
            </a:lvl5pPr>
            <a:lvl6pPr marL="3251107" indent="0">
              <a:buNone/>
              <a:defRPr sz="2300" b="1"/>
            </a:lvl6pPr>
            <a:lvl7pPr marL="3901326" indent="0">
              <a:buNone/>
              <a:defRPr sz="2300" b="1"/>
            </a:lvl7pPr>
            <a:lvl8pPr marL="4551548" indent="0">
              <a:buNone/>
              <a:defRPr sz="2300" b="1"/>
            </a:lvl8pPr>
            <a:lvl9pPr marL="5201769" indent="0">
              <a:buNone/>
              <a:defRPr sz="2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6" y="3479800"/>
            <a:ext cx="8083551" cy="6322061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5" y="436880"/>
            <a:ext cx="6016627" cy="185928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1" y="436883"/>
            <a:ext cx="10223500" cy="9364981"/>
          </a:xfrm>
        </p:spPr>
        <p:txBody>
          <a:bodyPr/>
          <a:lstStyle>
            <a:lvl1pPr>
              <a:defRPr sz="4600"/>
            </a:lvl1pPr>
            <a:lvl2pPr>
              <a:defRPr sz="40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5" y="2296163"/>
            <a:ext cx="6016627" cy="7505701"/>
          </a:xfrm>
        </p:spPr>
        <p:txBody>
          <a:bodyPr/>
          <a:lstStyle>
            <a:lvl1pPr marL="0" indent="0">
              <a:buNone/>
              <a:defRPr sz="2000"/>
            </a:lvl1pPr>
            <a:lvl2pPr marL="650221" indent="0">
              <a:buNone/>
              <a:defRPr sz="1700"/>
            </a:lvl2pPr>
            <a:lvl3pPr marL="1300443" indent="0">
              <a:buNone/>
              <a:defRPr sz="1400"/>
            </a:lvl3pPr>
            <a:lvl4pPr marL="1950664" indent="0">
              <a:buNone/>
              <a:defRPr sz="1300"/>
            </a:lvl4pPr>
            <a:lvl5pPr marL="2600885" indent="0">
              <a:buNone/>
              <a:defRPr sz="1300"/>
            </a:lvl5pPr>
            <a:lvl6pPr marL="3251107" indent="0">
              <a:buNone/>
              <a:defRPr sz="1300"/>
            </a:lvl6pPr>
            <a:lvl7pPr marL="3901326" indent="0">
              <a:buNone/>
              <a:defRPr sz="1300"/>
            </a:lvl7pPr>
            <a:lvl8pPr marL="4551548" indent="0">
              <a:buNone/>
              <a:defRPr sz="1300"/>
            </a:lvl8pPr>
            <a:lvl9pPr marL="520176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7680961"/>
            <a:ext cx="10972800" cy="90678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980440"/>
            <a:ext cx="10972800" cy="6583680"/>
          </a:xfrm>
        </p:spPr>
        <p:txBody>
          <a:bodyPr/>
          <a:lstStyle>
            <a:lvl1pPr marL="0" indent="0">
              <a:buNone/>
              <a:defRPr sz="4600"/>
            </a:lvl1pPr>
            <a:lvl2pPr marL="650221" indent="0">
              <a:buNone/>
              <a:defRPr sz="4000"/>
            </a:lvl2pPr>
            <a:lvl3pPr marL="1300443" indent="0">
              <a:buNone/>
              <a:defRPr sz="3400"/>
            </a:lvl3pPr>
            <a:lvl4pPr marL="1950664" indent="0">
              <a:buNone/>
              <a:defRPr sz="2800"/>
            </a:lvl4pPr>
            <a:lvl5pPr marL="2600885" indent="0">
              <a:buNone/>
              <a:defRPr sz="2800"/>
            </a:lvl5pPr>
            <a:lvl6pPr marL="3251107" indent="0">
              <a:buNone/>
              <a:defRPr sz="2800"/>
            </a:lvl6pPr>
            <a:lvl7pPr marL="3901326" indent="0">
              <a:buNone/>
              <a:defRPr sz="2800"/>
            </a:lvl7pPr>
            <a:lvl8pPr marL="4551548" indent="0">
              <a:buNone/>
              <a:defRPr sz="2800"/>
            </a:lvl8pPr>
            <a:lvl9pPr marL="5201769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8587742"/>
            <a:ext cx="10972800" cy="1287779"/>
          </a:xfrm>
        </p:spPr>
        <p:txBody>
          <a:bodyPr/>
          <a:lstStyle>
            <a:lvl1pPr marL="0" indent="0">
              <a:buNone/>
              <a:defRPr sz="2000"/>
            </a:lvl1pPr>
            <a:lvl2pPr marL="650221" indent="0">
              <a:buNone/>
              <a:defRPr sz="1700"/>
            </a:lvl2pPr>
            <a:lvl3pPr marL="1300443" indent="0">
              <a:buNone/>
              <a:defRPr sz="1400"/>
            </a:lvl3pPr>
            <a:lvl4pPr marL="1950664" indent="0">
              <a:buNone/>
              <a:defRPr sz="1300"/>
            </a:lvl4pPr>
            <a:lvl5pPr marL="2600885" indent="0">
              <a:buNone/>
              <a:defRPr sz="1300"/>
            </a:lvl5pPr>
            <a:lvl6pPr marL="3251107" indent="0">
              <a:buNone/>
              <a:defRPr sz="1300"/>
            </a:lvl6pPr>
            <a:lvl7pPr marL="3901326" indent="0">
              <a:buNone/>
              <a:defRPr sz="1300"/>
            </a:lvl7pPr>
            <a:lvl8pPr marL="4551548" indent="0">
              <a:buNone/>
              <a:defRPr sz="1300"/>
            </a:lvl8pPr>
            <a:lvl9pPr marL="520176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439421"/>
            <a:ext cx="16459200" cy="1828800"/>
          </a:xfrm>
          <a:prstGeom prst="rect">
            <a:avLst/>
          </a:prstGeom>
        </p:spPr>
        <p:txBody>
          <a:bodyPr vert="horz" lIns="130045" tIns="65022" rIns="130045" bIns="6502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2560325"/>
            <a:ext cx="16459200" cy="7241541"/>
          </a:xfrm>
          <a:prstGeom prst="rect">
            <a:avLst/>
          </a:prstGeom>
        </p:spPr>
        <p:txBody>
          <a:bodyPr vert="horz" lIns="130045" tIns="65022" rIns="130045" bIns="6502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10170164"/>
            <a:ext cx="4267200" cy="584200"/>
          </a:xfrm>
          <a:prstGeom prst="rect">
            <a:avLst/>
          </a:prstGeom>
        </p:spPr>
        <p:txBody>
          <a:bodyPr vert="horz" lIns="130045" tIns="65022" rIns="130045" bIns="65022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3992A-4AC6-4CE8-AD1F-1154A74B0493}" type="datetimeFigureOut">
              <a:rPr lang="en-US" smtClean="0"/>
              <a:pPr/>
              <a:t>8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0" y="10170164"/>
            <a:ext cx="5791200" cy="584200"/>
          </a:xfrm>
          <a:prstGeom prst="rect">
            <a:avLst/>
          </a:prstGeom>
        </p:spPr>
        <p:txBody>
          <a:bodyPr vert="horz" lIns="130045" tIns="65022" rIns="130045" bIns="65022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10170164"/>
            <a:ext cx="4267200" cy="584200"/>
          </a:xfrm>
          <a:prstGeom prst="rect">
            <a:avLst/>
          </a:prstGeom>
        </p:spPr>
        <p:txBody>
          <a:bodyPr vert="horz" lIns="130045" tIns="65022" rIns="130045" bIns="65022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598BB-4675-40F1-81B3-6E9F640A928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00443" rtl="0" eaLnBrk="1" latinLnBrk="0" hangingPunct="1">
        <a:spcBef>
          <a:spcPct val="0"/>
        </a:spcBef>
        <a:buNone/>
        <a:defRPr sz="6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7667" indent="-487667" algn="l" defTabSz="1300443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1pPr>
      <a:lvl2pPr marL="1056609" indent="-406388" algn="l" defTabSz="1300443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553" indent="-325111" algn="l" defTabSz="1300443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75775" indent="-325111" algn="l" defTabSz="1300443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25996" indent="-325111" algn="l" defTabSz="1300443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76216" indent="-325111" algn="l" defTabSz="1300443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226437" indent="-325111" algn="l" defTabSz="1300443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76658" indent="-325111" algn="l" defTabSz="1300443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26880" indent="-325111" algn="l" defTabSz="1300443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50221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443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50664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00885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251107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1326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51548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01769" algn="l" defTabSz="1300443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52400" y="990600"/>
          <a:ext cx="17983200" cy="8312778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6019800"/>
                <a:gridCol w="11963400"/>
              </a:tblGrid>
              <a:tr h="505544">
                <a:tc>
                  <a:txBody>
                    <a:bodyPr/>
                    <a:lstStyle/>
                    <a:p>
                      <a:pPr marL="0" marR="0" indent="0" algn="l" defTabSz="91438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dirty="0" smtClean="0">
                          <a:latin typeface="Arial" pitchFamily="34" charset="0"/>
                          <a:cs typeface="Arial" pitchFamily="34" charset="0"/>
                        </a:rPr>
                        <a:t>Change in </a:t>
                      </a:r>
                      <a:r>
                        <a:rPr lang="en-US" sz="2000" dirty="0" err="1" smtClean="0">
                          <a:latin typeface="Arial" pitchFamily="34" charset="0"/>
                          <a:cs typeface="Arial" pitchFamily="34" charset="0"/>
                        </a:rPr>
                        <a:t>Pufs</a:t>
                      </a:r>
                      <a:r>
                        <a:rPr lang="en-US" sz="2000" baseline="0" dirty="0" smtClean="0">
                          <a:latin typeface="Arial" pitchFamily="34" charset="0"/>
                          <a:cs typeface="Arial" pitchFamily="34" charset="0"/>
                        </a:rPr>
                        <a:t> and their </a:t>
                      </a:r>
                      <a:r>
                        <a:rPr lang="en-US" sz="2000" dirty="0" smtClean="0">
                          <a:latin typeface="Arial" pitchFamily="34" charset="0"/>
                          <a:cs typeface="Arial" pitchFamily="34" charset="0"/>
                        </a:rPr>
                        <a:t>RNA</a:t>
                      </a:r>
                      <a:r>
                        <a:rPr lang="en-US" sz="2000" baseline="0" dirty="0" smtClean="0">
                          <a:latin typeface="Arial" pitchFamily="34" charset="0"/>
                          <a:cs typeface="Arial" pitchFamily="34" charset="0"/>
                        </a:rPr>
                        <a:t> Interactions</a:t>
                      </a:r>
                      <a:endParaRPr lang="en-US" sz="20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dirty="0" smtClean="0">
                          <a:latin typeface="Arial" pitchFamily="34" charset="0"/>
                          <a:cs typeface="Arial" pitchFamily="34" charset="0"/>
                        </a:rPr>
                        <a:t>Analogous change in</a:t>
                      </a:r>
                      <a:r>
                        <a:rPr lang="en-US" sz="2000" baseline="0" dirty="0" smtClean="0">
                          <a:latin typeface="Arial" pitchFamily="34" charset="0"/>
                          <a:cs typeface="Arial" pitchFamily="34" charset="0"/>
                        </a:rPr>
                        <a:t> transcription factors and their </a:t>
                      </a:r>
                      <a:r>
                        <a:rPr lang="en-US" sz="2000" dirty="0" smtClean="0">
                          <a:latin typeface="Arial" pitchFamily="34" charset="0"/>
                          <a:cs typeface="Arial" pitchFamily="34" charset="0"/>
                        </a:rPr>
                        <a:t>gene regulation</a:t>
                      </a:r>
                      <a:endParaRPr lang="en-US" sz="2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4498">
                <a:tc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87782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binding specificity tends to be conserved more so than interactions with specific RNAs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23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Tuch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et al. Th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evolution of combinatorial gene regulation in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8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47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Borneman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Divergenc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transcription factor binding sites across related yeast species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Scienc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2007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48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Cain et al. A conserved transcriptional regulator governs fungal morphology in widely diverged species. </a:t>
                      </a:r>
                      <a:r>
                        <a:rPr lang="en-US" sz="1400" b="1" dirty="0" smtClean="0">
                          <a:latin typeface="Arial" pitchFamily="34" charset="0"/>
                          <a:cs typeface="Arial" pitchFamily="34" charset="0"/>
                        </a:rPr>
                        <a:t>Genetic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2012</a:t>
                      </a: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49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Schmidt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et al. Five-vertebrate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hIP-seq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reveals the evolutionary dynamics of transcription factor binding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Scienc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201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51206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binding specificity has changed over evolution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130044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0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Baker et al. Extensive DNA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-binding specificity divergence of a conserved transcription regulator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PNA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2011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1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Lavoie et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al. Evolutionary tinkering with conserved components of a transcriptional regulatory network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0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69494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Binding specificity of Puf3 in </a:t>
                      </a:r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accharomycotina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co-evolved with its targets (-2C preference) </a:t>
                      </a:r>
                      <a:endParaRPr lang="en-US" sz="16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64 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Gasch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Conservation and evol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i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-regulatory systems in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ascomycet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4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1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Lavoie et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al. Evolutionary tinkering with conserved components of a transcriptional regulatory network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0</a:t>
                      </a: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2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Kuo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et al.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oevol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within a transcriptional network by compensatory trans and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i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mutations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Genome Res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69494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Many RNA targets of </a:t>
                      </a:r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proteins tend to be conserved over millions of years but change over long evolutionary time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64 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Gasch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Conservation and evol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i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-regulatory systems in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ascomycet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4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3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ogue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Transcription factor substit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during the evolution of fungal ribosome regulation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Mol Cell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8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4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Tanay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Conservation and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evolability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in regulatory networks: the evolution of ribosomal regulation in yeast.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PNAS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5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106070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onserved </a:t>
                      </a:r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targets tend to encode functionally related proteins, and each set of related targets tend to be gained or lost in a coordinated fashion, thus acting as a unit or module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64 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Gasch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Conservation and evol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i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-regulatory systems in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ascomycet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4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indent="0" algn="l" defTabSz="130044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1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Lavoie et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al. Evolutionary tinkering with conserved components of a transcriptional regulatory network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0</a:t>
                      </a:r>
                    </a:p>
                    <a:p>
                      <a:pPr marL="0" marR="0" indent="0" algn="l" defTabSz="130044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3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ogue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Transcription factor substit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during the evolution of fungal ribosome regulation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Mol Cell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8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5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Ihmel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Rewiring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the yeast transcriptional network through the evolution of motif usage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Science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5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6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abib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A functional selection model explains evolutionary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robustness despite plasticity in regulatory networks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Mol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Syst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2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87782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s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can be co-opted to regulate new target RNAs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64 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Gasch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Conservation and evol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cis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-regulatory systems in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ascomycet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4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23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Tuch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et al. Th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evolution of combinatorial gene regulation in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8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6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abib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A functional selection model explains evolutionary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robustness despite plasticity in regulatory networks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Mol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Syst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2</a:t>
                      </a: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7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Martchenko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et al. Transcriptional rewiring of fungal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galactos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metabolism circuitry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Curr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7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877824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in</a:t>
                      </a:r>
                      <a:r>
                        <a:rPr lang="en-US" sz="1600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of </a:t>
                      </a:r>
                      <a:r>
                        <a:rPr lang="en-US" sz="1600" kern="1200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targets can bring 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modules together at different times in history,</a:t>
                      </a:r>
                      <a:r>
                        <a:rPr lang="en-US" sz="1600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otentially for co-regulated expression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– Lavoie et al. Rearrangements of the transcriptional regulatory networks of metabolic pathways in fungi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Curr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Opin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Micro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9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indent="0" algn="l" defTabSz="130044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1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Lavoie et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al. Evolutionary tinkering with conserved components of a transcriptional regulatory network.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PLoS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iol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0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indent="0" algn="l" defTabSz="130044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3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ogue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Transcription factor substitu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during the evolution of fungal ribosome regulation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. Mol Cell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08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5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Ihmels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et al. Rewiring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of the yeast transcriptional network through the evolution of motif usage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Scienc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200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773321">
                <a:tc>
                  <a:txBody>
                    <a:bodyPr/>
                    <a:lstStyle/>
                    <a:p>
                      <a:pPr algn="l"/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targets can change independently of changes in </a:t>
                      </a:r>
                      <a:r>
                        <a:rPr lang="en-US" sz="160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uf</a:t>
                      </a:r>
                      <a:r>
                        <a:rPr lang="en-US" sz="160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copy number, but copy number changes have been followed by changes in RNA targets or RNA binding specificity</a:t>
                      </a:r>
                      <a:endParaRPr 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8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</a:t>
                      </a:r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Hittinger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and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Carroll. Gene duplication and the adaptive evolution of a classic genetic switch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Nature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2007</a:t>
                      </a:r>
                      <a:endParaRPr lang="en-US" sz="140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l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59 </a:t>
                      </a:r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– Perez et al. How duplicated transcription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regulators can diversify to govern the expression of </a:t>
                      </a:r>
                      <a:r>
                        <a:rPr lang="en-US" sz="1400" baseline="0" dirty="0" err="1" smtClean="0">
                          <a:latin typeface="Arial" pitchFamily="34" charset="0"/>
                          <a:cs typeface="Arial" pitchFamily="34" charset="0"/>
                        </a:rPr>
                        <a:t>nonoverlapping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 sets of genes. </a:t>
                      </a:r>
                      <a:r>
                        <a:rPr lang="en-US" sz="1400" b="1" baseline="0" dirty="0" smtClean="0">
                          <a:latin typeface="Arial" pitchFamily="34" charset="0"/>
                          <a:cs typeface="Arial" pitchFamily="34" charset="0"/>
                        </a:rPr>
                        <a:t>Genes Dev </a:t>
                      </a:r>
                      <a:r>
                        <a:rPr lang="en-US" sz="1400" baseline="0" dirty="0" smtClean="0">
                          <a:latin typeface="Arial" pitchFamily="34" charset="0"/>
                          <a:cs typeface="Arial" pitchFamily="34" charset="0"/>
                        </a:rPr>
                        <a:t>2014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172430">
                <a:tc>
                  <a:txBody>
                    <a:bodyPr/>
                    <a:lstStyle/>
                    <a:p>
                      <a:pPr algn="r"/>
                      <a:endParaRPr lang="en-US" sz="2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2880" marR="182880" marT="73152" marB="7315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46</TotalTime>
  <Words>704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Stanford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reg</dc:creator>
  <cp:lastModifiedBy>Greg</cp:lastModifiedBy>
  <cp:revision>1352</cp:revision>
  <dcterms:created xsi:type="dcterms:W3CDTF">2013-06-15T03:10:32Z</dcterms:created>
  <dcterms:modified xsi:type="dcterms:W3CDTF">2015-08-08T17:13:36Z</dcterms:modified>
</cp:coreProperties>
</file>